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5" r:id="rId2"/>
    <p:sldId id="276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4694"/>
  </p:normalViewPr>
  <p:slideViewPr>
    <p:cSldViewPr snapToGrid="0" snapToObjects="1">
      <p:cViewPr>
        <p:scale>
          <a:sx n="122" d="100"/>
          <a:sy n="122" d="100"/>
        </p:scale>
        <p:origin x="648" y="2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FB18A5-A81C-9F41-BC29-5E4684F6AEC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62117D4-46DD-B94F-B828-C500826A466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E91EA2-0FB7-0F44-9434-C4EA8084A0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232B6-A558-DB47-BD61-6468518D6A3D}" type="datetimeFigureOut">
              <a:rPr lang="en-US" smtClean="0"/>
              <a:t>4/12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4EC5F7-E84A-E34B-A5F3-9C564D0F55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C7AF63-4D12-6A4E-9D32-AC3304A87B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0340D-66B8-DF4A-A457-04C501143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00815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96F2D1-313C-2144-BB73-374165A73F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7A91EC7-4AFE-C84A-94E9-67030A37044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EAAC3B-C234-C047-9FA2-2835942BEF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232B6-A558-DB47-BD61-6468518D6A3D}" type="datetimeFigureOut">
              <a:rPr lang="en-US" smtClean="0"/>
              <a:t>4/12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71ACFD-7AFE-8A40-AE47-8C5D62EF13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C8DD5E-1E79-E941-A933-185432E506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0340D-66B8-DF4A-A457-04C501143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20290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AA9A894-8F65-654F-AE15-1A4576434A6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6985308-242C-A84C-9C7A-175C5B557B7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D9AE5C-6798-1D49-B138-227714AD54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232B6-A558-DB47-BD61-6468518D6A3D}" type="datetimeFigureOut">
              <a:rPr lang="en-US" smtClean="0"/>
              <a:t>4/12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3CFB43-3ECC-F646-B67A-088EC8C75C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3ADE6E-DADF-E64D-A38F-4387D55227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0340D-66B8-DF4A-A457-04C501143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81200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1A23F0-5428-BF4F-84BE-CF012F9A3E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4AB873C-984D-4944-82BA-25AD04CF03A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7EA937-58B5-0849-B02F-F3BA5AE873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232B6-A558-DB47-BD61-6468518D6A3D}" type="datetimeFigureOut">
              <a:rPr lang="en-US" smtClean="0"/>
              <a:t>4/12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BF8540-2FB3-564E-94D3-5FDD6C32DD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D7ED9D-0580-F24A-BC12-B6EBE4C280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0340D-66B8-DF4A-A457-04C501143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47188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3E5724-CD39-AD42-AE44-AD963B730F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FEC88DE-D890-5747-B02D-8CA46FF788E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77E866-F37C-4B4F-A751-6FAF7E236C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232B6-A558-DB47-BD61-6468518D6A3D}" type="datetimeFigureOut">
              <a:rPr lang="en-US" smtClean="0"/>
              <a:t>4/12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2AF03F-C839-514E-91C6-A0BE8F9B60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7F2D72-A4CA-AC41-AAA5-22D8D65CEB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0340D-66B8-DF4A-A457-04C501143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86188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EC6A52-4E44-7948-AB5A-1CB6C2DFA0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1FADC42-BED3-5A4E-9770-AC8B3CAE297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73D5525-836E-E647-AB83-CC0A3DAFE15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2BB13BA-3CF2-EA43-A3C2-27AFA77A67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232B6-A558-DB47-BD61-6468518D6A3D}" type="datetimeFigureOut">
              <a:rPr lang="en-US" smtClean="0"/>
              <a:t>4/12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C6A67BA-606B-3C4F-A3EF-C9ADCF853F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C8A3F90-33CF-7942-AAE0-1C2B113CC0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0340D-66B8-DF4A-A457-04C501143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6962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EF3856-FE47-BA47-8978-4C735631B4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797B42A-89F1-6945-AE63-528ED5B736A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59EA634-CB28-4143-A8E4-55949669495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CC2C908-388B-B046-A1D6-082F596C2F4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603A126-33AC-EF40-B88C-C212988C463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9D2848D-A64E-FA45-A693-7DC8FD4E75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232B6-A558-DB47-BD61-6468518D6A3D}" type="datetimeFigureOut">
              <a:rPr lang="en-US" smtClean="0"/>
              <a:t>4/12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4971CDB-7E67-704F-9638-F259378036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786B398-122A-5A41-B64F-16A2C93BE2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0340D-66B8-DF4A-A457-04C501143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9200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8303A3-D339-2746-9DB0-9DEBE8A576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5E8AC4D-31BF-CC45-B26B-4E18593FDA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232B6-A558-DB47-BD61-6468518D6A3D}" type="datetimeFigureOut">
              <a:rPr lang="en-US" smtClean="0"/>
              <a:t>4/12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7D1E8EA-53C4-F749-A24F-19D51B6DEC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ACF4A8F-9151-F64F-8E1C-5D32839B2C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0340D-66B8-DF4A-A457-04C501143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5709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7A3DBCA-B0C6-4048-B094-2C8E6E0E10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232B6-A558-DB47-BD61-6468518D6A3D}" type="datetimeFigureOut">
              <a:rPr lang="en-US" smtClean="0"/>
              <a:t>4/12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7B7FCF2-3150-CB42-B17C-DE0DB32401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1AEBAD7-5EF5-6747-85E0-00A28F59F6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0340D-66B8-DF4A-A457-04C501143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43522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8D10FD-45C4-B04E-B672-0D3D1629EF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A5642E7-85B5-614F-9A2D-D8B39D93AC0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8BE0988-6A98-4B4A-BBAE-79A81A7BC3A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EC8115F-2589-394E-9CEC-DF90C07AED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232B6-A558-DB47-BD61-6468518D6A3D}" type="datetimeFigureOut">
              <a:rPr lang="en-US" smtClean="0"/>
              <a:t>4/12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68F4CDA-125C-F747-8AF2-8B4715ACB5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B2BFB4B-8816-A746-8A79-290D9D2265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0340D-66B8-DF4A-A457-04C501143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13582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91B673-D2AB-414A-9F56-FABD662789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BEB6068-D5B1-6E41-897A-CBD111BE9D3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12ADF13-3989-7D48-A186-7E0719E3D03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7439F42-0033-3A4F-AC73-D92E8986C4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232B6-A558-DB47-BD61-6468518D6A3D}" type="datetimeFigureOut">
              <a:rPr lang="en-US" smtClean="0"/>
              <a:t>4/12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17D497D-AEBF-3C43-8F08-2A7D589DA9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C607425-42E4-D04D-A7C0-FE41155E0A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0340D-66B8-DF4A-A457-04C501143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79831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34F27C7-4298-534E-A44D-8C1E4C460B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2B34451-4D53-B141-A814-1701C28A12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728388-D51C-AB4E-AAE4-FC0179BEB8B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C232B6-A558-DB47-BD61-6468518D6A3D}" type="datetimeFigureOut">
              <a:rPr lang="en-US" smtClean="0"/>
              <a:t>4/12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A59327-37EB-D24D-8D6B-8589E285AE4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A7553C-36C2-844D-9490-395FB321412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00340D-66B8-DF4A-A457-04C501143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52937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extBox 29">
            <a:extLst>
              <a:ext uri="{FF2B5EF4-FFF2-40B4-BE49-F238E27FC236}">
                <a16:creationId xmlns:a16="http://schemas.microsoft.com/office/drawing/2014/main" id="{B988E36F-6FDD-F94F-BEA5-864D043D1B71}"/>
              </a:ext>
            </a:extLst>
          </p:cNvPr>
          <p:cNvSpPr txBox="1"/>
          <p:nvPr/>
        </p:nvSpPr>
        <p:spPr>
          <a:xfrm>
            <a:off x="228886" y="139753"/>
            <a:ext cx="2286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 1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4AD09213-0CB9-0940-B1AB-CB0CC7EBE38F}"/>
              </a:ext>
            </a:extLst>
          </p:cNvPr>
          <p:cNvGrpSpPr/>
          <p:nvPr/>
        </p:nvGrpSpPr>
        <p:grpSpPr>
          <a:xfrm>
            <a:off x="95322" y="509085"/>
            <a:ext cx="12068965" cy="4832011"/>
            <a:chOff x="95322" y="509085"/>
            <a:chExt cx="12068965" cy="4832011"/>
          </a:xfrm>
        </p:grpSpPr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553B043D-F399-D240-A0E0-2AC47E99D73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716" r="30540"/>
            <a:stretch/>
          </p:blipFill>
          <p:spPr bwMode="auto">
            <a:xfrm>
              <a:off x="108785" y="1806376"/>
              <a:ext cx="3761758" cy="2970247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29217B1E-3377-E840-88D6-09676241B071}"/>
                </a:ext>
              </a:extLst>
            </p:cNvPr>
            <p:cNvSpPr txBox="1"/>
            <p:nvPr/>
          </p:nvSpPr>
          <p:spPr>
            <a:xfrm>
              <a:off x="4438048" y="509085"/>
              <a:ext cx="3790910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 dirty="0">
                  <a:solidFill>
                    <a:schemeClr val="accent1">
                      <a:lumMod val="75000"/>
                    </a:schemeClr>
                  </a:solidFill>
                </a:rPr>
                <a:t>Freedom from Death or HFH</a:t>
              </a:r>
            </a:p>
          </p:txBody>
        </p:sp>
        <p:grpSp>
          <p:nvGrpSpPr>
            <p:cNvPr id="29" name="Group 28">
              <a:extLst>
                <a:ext uri="{FF2B5EF4-FFF2-40B4-BE49-F238E27FC236}">
                  <a16:creationId xmlns:a16="http://schemas.microsoft.com/office/drawing/2014/main" id="{07D28651-26D3-7942-954D-183EDF37794B}"/>
                </a:ext>
              </a:extLst>
            </p:cNvPr>
            <p:cNvGrpSpPr/>
            <p:nvPr/>
          </p:nvGrpSpPr>
          <p:grpSpPr>
            <a:xfrm>
              <a:off x="95322" y="1226634"/>
              <a:ext cx="12068965" cy="4114462"/>
              <a:chOff x="95322" y="1226634"/>
              <a:chExt cx="12068965" cy="4114462"/>
            </a:xfrm>
          </p:grpSpPr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1F5E79F4-34CB-47AF-8FCB-0C28E066C5E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t="7330" r="56091"/>
              <a:stretch/>
            </p:blipFill>
            <p:spPr>
              <a:xfrm>
                <a:off x="4123696" y="1866376"/>
                <a:ext cx="4011522" cy="3474720"/>
              </a:xfrm>
              <a:prstGeom prst="rect">
                <a:avLst/>
              </a:prstGeom>
            </p:spPr>
          </p:pic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68915E43-160B-4E41-97A0-16D6287EEA2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51788" t="7330" r="4304"/>
              <a:stretch/>
            </p:blipFill>
            <p:spPr>
              <a:xfrm>
                <a:off x="8152763" y="1816272"/>
                <a:ext cx="4011524" cy="3474720"/>
              </a:xfrm>
              <a:prstGeom prst="rect">
                <a:avLst/>
              </a:prstGeom>
            </p:spPr>
          </p:pic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1546DDA8-8131-C64F-B6E2-EE775FBD794B}"/>
                  </a:ext>
                </a:extLst>
              </p:cNvPr>
              <p:cNvSpPr txBox="1"/>
              <p:nvPr/>
            </p:nvSpPr>
            <p:spPr>
              <a:xfrm>
                <a:off x="1014624" y="1226634"/>
                <a:ext cx="250151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/>
                  <a:t>Patients with LVEF ≥50%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FE762BDA-3864-4D41-8128-5CC7DF97E8E4}"/>
                  </a:ext>
                </a:extLst>
              </p:cNvPr>
              <p:cNvSpPr txBox="1"/>
              <p:nvPr/>
            </p:nvSpPr>
            <p:spPr>
              <a:xfrm>
                <a:off x="5375757" y="1226634"/>
                <a:ext cx="150740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/>
                  <a:t>HBP vs LBBAP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4556A336-A583-7C46-A0D9-DD1B70FAA3F9}"/>
                  </a:ext>
                </a:extLst>
              </p:cNvPr>
              <p:cNvSpPr txBox="1"/>
              <p:nvPr/>
            </p:nvSpPr>
            <p:spPr>
              <a:xfrm>
                <a:off x="9294637" y="1226634"/>
                <a:ext cx="126239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/>
                  <a:t>RVP vs BVP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67DE5C11-5256-A94D-AFFD-5FAA1650F8BB}"/>
                  </a:ext>
                </a:extLst>
              </p:cNvPr>
              <p:cNvSpPr txBox="1"/>
              <p:nvPr/>
            </p:nvSpPr>
            <p:spPr>
              <a:xfrm>
                <a:off x="3441927" y="1929161"/>
                <a:ext cx="604653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solidFill>
                      <a:schemeClr val="accent1">
                        <a:lumMod val="75000"/>
                      </a:schemeClr>
                    </a:solidFill>
                  </a:rPr>
                  <a:t>-- CSP</a:t>
                </a:r>
              </a:p>
              <a:p>
                <a:r>
                  <a:rPr lang="en-US" sz="1400" dirty="0">
                    <a:solidFill>
                      <a:srgbClr val="008F00"/>
                    </a:solidFill>
                  </a:rPr>
                  <a:t>-- CP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459B01E6-0438-AC48-B3F8-1B930980094E}"/>
                  </a:ext>
                </a:extLst>
              </p:cNvPr>
              <p:cNvSpPr txBox="1"/>
              <p:nvPr/>
            </p:nvSpPr>
            <p:spPr>
              <a:xfrm>
                <a:off x="6925827" y="1929161"/>
                <a:ext cx="800091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solidFill>
                      <a:schemeClr val="accent1">
                        <a:lumMod val="75000"/>
                      </a:schemeClr>
                    </a:solidFill>
                  </a:rPr>
                  <a:t>-- HBP</a:t>
                </a:r>
              </a:p>
              <a:p>
                <a:r>
                  <a:rPr lang="en-US" sz="1400" dirty="0">
                    <a:solidFill>
                      <a:srgbClr val="008F00"/>
                    </a:solidFill>
                  </a:rPr>
                  <a:t>-- LBBAP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24480D8E-64D2-5E48-9C9F-B5FD31EDECCD}"/>
                  </a:ext>
                </a:extLst>
              </p:cNvPr>
              <p:cNvSpPr txBox="1"/>
              <p:nvPr/>
            </p:nvSpPr>
            <p:spPr>
              <a:xfrm>
                <a:off x="10722044" y="1934595"/>
                <a:ext cx="624658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solidFill>
                      <a:schemeClr val="accent1">
                        <a:lumMod val="75000"/>
                      </a:schemeClr>
                    </a:solidFill>
                  </a:rPr>
                  <a:t>-- RVP</a:t>
                </a:r>
              </a:p>
              <a:p>
                <a:r>
                  <a:rPr lang="en-US" sz="1400" dirty="0">
                    <a:solidFill>
                      <a:srgbClr val="008F00"/>
                    </a:solidFill>
                  </a:rPr>
                  <a:t>-- BVP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71B44733-8BC2-AA45-BD77-F9FDE8C65723}"/>
                  </a:ext>
                </a:extLst>
              </p:cNvPr>
              <p:cNvSpPr txBox="1"/>
              <p:nvPr/>
            </p:nvSpPr>
            <p:spPr>
              <a:xfrm>
                <a:off x="5998022" y="2650476"/>
                <a:ext cx="1349298" cy="36799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endParaRPr lang="en-US" dirty="0"/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A1174E2C-31EF-1C42-B1D6-C1A66491C07F}"/>
                  </a:ext>
                </a:extLst>
              </p:cNvPr>
              <p:cNvSpPr txBox="1"/>
              <p:nvPr/>
            </p:nvSpPr>
            <p:spPr>
              <a:xfrm>
                <a:off x="4890142" y="3933059"/>
                <a:ext cx="134524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HR 0.75; p=0.41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2763036E-6542-2445-BF59-744C6C6D7303}"/>
                  </a:ext>
                </a:extLst>
              </p:cNvPr>
              <p:cNvSpPr txBox="1"/>
              <p:nvPr/>
            </p:nvSpPr>
            <p:spPr>
              <a:xfrm>
                <a:off x="10351204" y="2862012"/>
                <a:ext cx="1349298" cy="36799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endParaRPr lang="en-US" dirty="0"/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6231A3ED-704F-0846-9DBF-2DF8A2F072FF}"/>
                  </a:ext>
                </a:extLst>
              </p:cNvPr>
              <p:cNvSpPr txBox="1"/>
              <p:nvPr/>
            </p:nvSpPr>
            <p:spPr>
              <a:xfrm>
                <a:off x="8813285" y="3908822"/>
                <a:ext cx="134524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HR 0.72; p=0.18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944574E3-7542-7340-BE52-4BFDE5D043B1}"/>
                  </a:ext>
                </a:extLst>
              </p:cNvPr>
              <p:cNvSpPr txBox="1"/>
              <p:nvPr/>
            </p:nvSpPr>
            <p:spPr>
              <a:xfrm>
                <a:off x="228886" y="4666666"/>
                <a:ext cx="3894810" cy="40011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/>
                  <a:t>CSP   63              35                   19                 11                   4                  2</a:t>
                </a:r>
              </a:p>
              <a:p>
                <a:r>
                  <a:rPr lang="en-US" sz="1000" b="1" dirty="0"/>
                  <a:t>CP     46              25                   14                  9                    9                  3   	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34290A0E-8294-AE4A-BAFB-5A81C258D6C9}"/>
                  </a:ext>
                </a:extLst>
              </p:cNvPr>
              <p:cNvSpPr txBox="1"/>
              <p:nvPr/>
            </p:nvSpPr>
            <p:spPr>
              <a:xfrm>
                <a:off x="4123694" y="4666666"/>
                <a:ext cx="3971928" cy="40011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/>
                  <a:t>HBP       85           48                 29                    17                 37                 2</a:t>
                </a:r>
              </a:p>
              <a:p>
                <a:r>
                  <a:rPr lang="en-US" sz="1000" b="1" dirty="0"/>
                  <a:t>LBBAP   26           12                  2                   	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F0114A9F-D82C-3B4D-AE6F-BF7FE2FC550C}"/>
                  </a:ext>
                </a:extLst>
              </p:cNvPr>
              <p:cNvSpPr txBox="1"/>
              <p:nvPr/>
            </p:nvSpPr>
            <p:spPr>
              <a:xfrm>
                <a:off x="8241567" y="4616562"/>
                <a:ext cx="3894810" cy="40011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/>
                  <a:t>RVP     55              28                   15                   9                    9                  4</a:t>
                </a:r>
              </a:p>
              <a:p>
                <a:r>
                  <a:rPr lang="en-US" sz="1000" b="1" dirty="0"/>
                  <a:t>BVP     57              21                   14                   6                    4                  1   	</a:t>
                </a:r>
              </a:p>
            </p:txBody>
          </p:sp>
          <p:sp>
            <p:nvSpPr>
              <p:cNvPr id="24" name="Rectangle 23">
                <a:extLst>
                  <a:ext uri="{FF2B5EF4-FFF2-40B4-BE49-F238E27FC236}">
                    <a16:creationId xmlns:a16="http://schemas.microsoft.com/office/drawing/2014/main" id="{E4B4BE5E-ED3E-B140-AB41-4B373C24A537}"/>
                  </a:ext>
                </a:extLst>
              </p:cNvPr>
              <p:cNvSpPr/>
              <p:nvPr/>
            </p:nvSpPr>
            <p:spPr>
              <a:xfrm>
                <a:off x="95322" y="1226634"/>
                <a:ext cx="3912835" cy="3840142"/>
              </a:xfrm>
              <a:prstGeom prst="rect">
                <a:avLst/>
              </a:prstGeom>
              <a:noFill/>
              <a:ln w="381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5" name="Rectangle 24">
                <a:extLst>
                  <a:ext uri="{FF2B5EF4-FFF2-40B4-BE49-F238E27FC236}">
                    <a16:creationId xmlns:a16="http://schemas.microsoft.com/office/drawing/2014/main" id="{FE6BF84C-21F6-8346-B466-6B7F102DEF77}"/>
                  </a:ext>
                </a:extLst>
              </p:cNvPr>
              <p:cNvSpPr/>
              <p:nvPr/>
            </p:nvSpPr>
            <p:spPr>
              <a:xfrm>
                <a:off x="4082281" y="1226634"/>
                <a:ext cx="4007781" cy="3840142"/>
              </a:xfrm>
              <a:prstGeom prst="rect">
                <a:avLst/>
              </a:prstGeom>
              <a:noFill/>
              <a:ln w="381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6" name="Rectangle 25">
                <a:extLst>
                  <a:ext uri="{FF2B5EF4-FFF2-40B4-BE49-F238E27FC236}">
                    <a16:creationId xmlns:a16="http://schemas.microsoft.com/office/drawing/2014/main" id="{A32BCC85-ACF6-A742-966D-CD3B40D56DD1}"/>
                  </a:ext>
                </a:extLst>
              </p:cNvPr>
              <p:cNvSpPr/>
              <p:nvPr/>
            </p:nvSpPr>
            <p:spPr>
              <a:xfrm>
                <a:off x="8139841" y="1228424"/>
                <a:ext cx="3971928" cy="3840142"/>
              </a:xfrm>
              <a:prstGeom prst="rect">
                <a:avLst/>
              </a:prstGeom>
              <a:noFill/>
              <a:ln w="381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7" name="Rectangle 26">
                <a:extLst>
                  <a:ext uri="{FF2B5EF4-FFF2-40B4-BE49-F238E27FC236}">
                    <a16:creationId xmlns:a16="http://schemas.microsoft.com/office/drawing/2014/main" id="{6C7B40BB-5919-9C4B-ADD3-1D90D60F3568}"/>
                  </a:ext>
                </a:extLst>
              </p:cNvPr>
              <p:cNvSpPr/>
              <p:nvPr/>
            </p:nvSpPr>
            <p:spPr>
              <a:xfrm>
                <a:off x="2442355" y="2154518"/>
                <a:ext cx="410308" cy="199292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8" name="Rectangle 27">
                <a:extLst>
                  <a:ext uri="{FF2B5EF4-FFF2-40B4-BE49-F238E27FC236}">
                    <a16:creationId xmlns:a16="http://schemas.microsoft.com/office/drawing/2014/main" id="{7C29DC57-498C-544E-9075-745B63A5300D}"/>
                  </a:ext>
                </a:extLst>
              </p:cNvPr>
              <p:cNvSpPr/>
              <p:nvPr/>
            </p:nvSpPr>
            <p:spPr>
              <a:xfrm>
                <a:off x="2372017" y="2135264"/>
                <a:ext cx="480646" cy="20428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69EED7E7-6353-8545-A23D-43BEE2F108C6}"/>
                </a:ext>
              </a:extLst>
            </p:cNvPr>
            <p:cNvSpPr txBox="1"/>
            <p:nvPr/>
          </p:nvSpPr>
          <p:spPr>
            <a:xfrm>
              <a:off x="785367" y="3908822"/>
              <a:ext cx="2123161" cy="33201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>
                <a:lnSpc>
                  <a:spcPts val="2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1400" dirty="0">
                  <a:effectLst/>
                  <a:ea typeface="Calibri" panose="020F0502020204030204" pitchFamily="34" charset="0"/>
                  <a:cs typeface="Times New Roman" panose="02020603050405020304" pitchFamily="18" charset="0"/>
                </a:rPr>
                <a:t>HR= 1.1, p =0.71</a:t>
              </a:r>
            </a:p>
          </p:txBody>
        </p:sp>
        <p:pic>
          <p:nvPicPr>
            <p:cNvPr id="33" name="Picture 32">
              <a:extLst>
                <a:ext uri="{FF2B5EF4-FFF2-40B4-BE49-F238E27FC236}">
                  <a16:creationId xmlns:a16="http://schemas.microsoft.com/office/drawing/2014/main" id="{248A14F5-D521-4D4F-A1DA-266CEB8EBC0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70988" r="58514" b="17561"/>
            <a:stretch/>
          </p:blipFill>
          <p:spPr>
            <a:xfrm>
              <a:off x="108175" y="4296590"/>
              <a:ext cx="3838579" cy="400110"/>
            </a:xfrm>
            <a:prstGeom prst="rect">
              <a:avLst/>
            </a:prstGeom>
          </p:spPr>
        </p:pic>
      </p:grpSp>
      <p:sp>
        <p:nvSpPr>
          <p:cNvPr id="34" name="TextBox 33">
            <a:extLst>
              <a:ext uri="{FF2B5EF4-FFF2-40B4-BE49-F238E27FC236}">
                <a16:creationId xmlns:a16="http://schemas.microsoft.com/office/drawing/2014/main" id="{6F8B5637-795C-F64F-9D06-49B8F7B098FE}"/>
              </a:ext>
            </a:extLst>
          </p:cNvPr>
          <p:cNvSpPr txBox="1"/>
          <p:nvPr/>
        </p:nvSpPr>
        <p:spPr>
          <a:xfrm rot="16200000">
            <a:off x="-291911" y="2960852"/>
            <a:ext cx="1106393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/>
              <a:t>Event-free rate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E6F13AB6-0279-634C-A6D8-F70FB7E326BA}"/>
              </a:ext>
            </a:extLst>
          </p:cNvPr>
          <p:cNvSpPr txBox="1"/>
          <p:nvPr/>
        </p:nvSpPr>
        <p:spPr>
          <a:xfrm rot="16200000">
            <a:off x="3684124" y="2960851"/>
            <a:ext cx="1106393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/>
              <a:t>Event-free rate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E772D8EE-4BCC-8B44-8930-50B26EA7BFD8}"/>
              </a:ext>
            </a:extLst>
          </p:cNvPr>
          <p:cNvSpPr txBox="1"/>
          <p:nvPr/>
        </p:nvSpPr>
        <p:spPr>
          <a:xfrm rot="16200000">
            <a:off x="7749188" y="2907507"/>
            <a:ext cx="1106393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/>
              <a:t>Event-free rate</a:t>
            </a:r>
          </a:p>
        </p:txBody>
      </p:sp>
    </p:spTree>
    <p:extLst>
      <p:ext uri="{BB962C8B-B14F-4D97-AF65-F5344CB8AC3E}">
        <p14:creationId xmlns:p14="http://schemas.microsoft.com/office/powerpoint/2010/main" val="9118289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967EE432-CDF1-AA43-99C4-C1C0586F1F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Supplemental Figure 1: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C7D768-E448-A04D-BB10-59187D4D63F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>
              <a:lnSpc>
                <a:spcPct val="150000"/>
              </a:lnSpc>
            </a:pPr>
            <a:r>
              <a:rPr lang="en-US" b="1" dirty="0"/>
              <a:t>Subgroup analysis of primary composite outcome of time to death or Heart Failure Hospitalizations (HFH) among patients with LVEF ≥50%, His bundle pacing (HBP) versus left bundle branch area pacing (LBBAP), right ventricular pacing (RVP) versus biventricular pacing (BVP). </a:t>
            </a:r>
            <a:r>
              <a:rPr lang="en-US" dirty="0"/>
              <a:t>No significant differences were observed among the subgroups analyzed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6282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64</Words>
  <Application>Microsoft Macintosh PowerPoint</Application>
  <PresentationFormat>Widescreen</PresentationFormat>
  <Paragraphs>25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Supplemental Figure 1: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jayaraman Md, Pugazhendhi</dc:creator>
  <cp:lastModifiedBy>Vijayaraman Md, Pugazhendhi</cp:lastModifiedBy>
  <cp:revision>3</cp:revision>
  <dcterms:created xsi:type="dcterms:W3CDTF">2022-01-30T23:35:12Z</dcterms:created>
  <dcterms:modified xsi:type="dcterms:W3CDTF">2022-04-13T01:35:34Z</dcterms:modified>
</cp:coreProperties>
</file>